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65" r:id="rId4"/>
    <p:sldId id="266" r:id="rId5"/>
    <p:sldId id="267" r:id="rId6"/>
    <p:sldId id="268" r:id="rId7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/>
    <p:restoredTop sz="93130"/>
  </p:normalViewPr>
  <p:slideViewPr>
    <p:cSldViewPr snapToGrid="0" snapToObjects="1">
      <p:cViewPr>
        <p:scale>
          <a:sx n="129" d="100"/>
          <a:sy n="129" d="100"/>
        </p:scale>
        <p:origin x="49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BC41468-3C34-134E-86C5-F5D9BB967A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3FA6CBE8-74B2-9240-96F0-8362437CDE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C39BC84-A968-F04C-BF36-FF2F03E50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3207A-CCB5-E14B-BE08-61F3E8AA9353}" type="datetimeFigureOut">
              <a:rPr lang="fr-FR" smtClean="0"/>
              <a:t>12/07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4FB6C18-BD2E-B049-95E1-23991D2A5F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86CAE2C-9DF4-AE44-885D-272817066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339B-EA7F-714A-B7DE-92AD817426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1592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DA255A3-F877-1B44-AEB6-DEC869209F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B42569E-E7B9-9B47-B437-449C96FDCB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21C9107-D333-6C4B-8789-AA02B55DB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3207A-CCB5-E14B-BE08-61F3E8AA9353}" type="datetimeFigureOut">
              <a:rPr lang="fr-FR" smtClean="0"/>
              <a:t>12/07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678F2EB-8DBA-734E-8B12-1D3F457B4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0561420-7673-AB41-840C-45218D2B4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339B-EA7F-714A-B7DE-92AD817426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8619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9BB7A198-90CD-7944-922B-566911590F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C18F308-1544-B04D-A371-207D0C8268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F721B8F-40EC-7343-B657-ACDD8B401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3207A-CCB5-E14B-BE08-61F3E8AA9353}" type="datetimeFigureOut">
              <a:rPr lang="fr-FR" smtClean="0"/>
              <a:t>12/07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4A2D319-5B36-644B-AFE6-E6A8F28094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7F88A5B-515B-AE47-8D3D-C184F4467C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339B-EA7F-714A-B7DE-92AD817426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2310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DD7FEBF-0FD2-744D-A4AC-4EB86C37BB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17DDC45-8F99-8142-B413-43BF09587D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DC22B99-D5A4-034E-8DC2-CDFFFB46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3207A-CCB5-E14B-BE08-61F3E8AA9353}" type="datetimeFigureOut">
              <a:rPr lang="fr-FR" smtClean="0"/>
              <a:t>12/07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99F1598-F330-6144-B175-EA91005B18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29E96C2-A6B2-5E42-9A17-B58A1C664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339B-EA7F-714A-B7DE-92AD817426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1707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D484C7B-8E0E-9C44-AF0D-59999FBE03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7E2448A-8F45-1C4B-92CD-4ABA988F8E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200F87A-F538-4342-8527-32284A4B06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3207A-CCB5-E14B-BE08-61F3E8AA9353}" type="datetimeFigureOut">
              <a:rPr lang="fr-FR" smtClean="0"/>
              <a:t>12/07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20CE183-9BD3-4541-8156-D96330B3D2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4FBB7C6-BFDA-6F42-9ACD-0ED19DCE7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339B-EA7F-714A-B7DE-92AD817426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0603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3C6CA17-1E94-9D4E-BCC2-C0A4ED329B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455A90C-DA4C-8A46-9CC7-30F9A9E753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6A63B6B-0FB2-3443-875A-48136C9415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EF7C36C-F6A9-C74F-B15D-B893DC9E11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3207A-CCB5-E14B-BE08-61F3E8AA9353}" type="datetimeFigureOut">
              <a:rPr lang="fr-FR" smtClean="0"/>
              <a:t>12/07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CA0935D-B070-E549-9570-AA423C565A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EF59B8D-86C1-FB43-8A36-F1384088C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339B-EA7F-714A-B7DE-92AD817426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9436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198C441-667E-CE47-B8C1-81F6211B26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4A33812-AFBA-C44D-9AC2-C90DA96477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AFBC356-FDA4-5B49-95A4-FDF7B928D4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C18095E9-4A73-AE4E-84A2-2E80543043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6A8D2075-C285-2744-9077-90EFBD97F4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4706752F-080E-1D41-B60E-35DBE1C6D3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3207A-CCB5-E14B-BE08-61F3E8AA9353}" type="datetimeFigureOut">
              <a:rPr lang="fr-FR" smtClean="0"/>
              <a:t>12/07/2019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88F0819F-92AD-534E-AD14-87D290451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D58824DD-310C-4C48-A3E8-938F50FB1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339B-EA7F-714A-B7DE-92AD817426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0615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6CA2834-B313-CE49-B2C8-F4EB39866B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5F24CD27-1535-8B48-AAF5-C2467457D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3207A-CCB5-E14B-BE08-61F3E8AA9353}" type="datetimeFigureOut">
              <a:rPr lang="fr-FR" smtClean="0"/>
              <a:t>12/07/2019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F4E5AE14-96DD-BE48-ABCC-C86F961C1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044FBAD-4126-1E4C-B00C-D23EFA1FF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339B-EA7F-714A-B7DE-92AD817426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8574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A633C944-6DC0-1D4C-B506-BC138F2855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3207A-CCB5-E14B-BE08-61F3E8AA9353}" type="datetimeFigureOut">
              <a:rPr lang="fr-FR" smtClean="0"/>
              <a:t>12/07/2019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99B4C35-D6DF-5947-86A5-EC7AC6FBC5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F00F8EA4-E54A-5A4C-98CD-A998A5014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339B-EA7F-714A-B7DE-92AD817426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8254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F9596A-FE17-2D48-B021-837AAC6F45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0349098-EB75-C64F-937D-478A34AA6D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EA2C85F-3B5F-244E-B28B-38AFEA9EFD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4C4FD2A-D363-994D-A03E-FB5986CAA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3207A-CCB5-E14B-BE08-61F3E8AA9353}" type="datetimeFigureOut">
              <a:rPr lang="fr-FR" smtClean="0"/>
              <a:t>12/07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E104577-A961-474C-81AF-0AE620EB0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D50F3CF-A876-D440-9F90-BBD8B2220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339B-EA7F-714A-B7DE-92AD817426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5387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D4E476E-4A16-8F41-A41C-D3AB686212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D7E5B78-1FE2-5F45-BF73-B677C01322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E79FC15-6449-B34C-BCEC-9846A24D85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0F3D8BF-C0A4-D948-A1DE-D421E7A35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3207A-CCB5-E14B-BE08-61F3E8AA9353}" type="datetimeFigureOut">
              <a:rPr lang="fr-FR" smtClean="0"/>
              <a:t>12/07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5B79F36-75AD-BE47-9139-AF3DD199C9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158F671-2E18-4449-9B6D-8ED98ABBFA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B5339B-EA7F-714A-B7DE-92AD817426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3956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3D14C800-6782-364E-BDDF-7A2EA4E3D5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1D08487-7333-7D42-A5E0-8918D5A124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68BFA3C-0546-FE4B-973F-F5381D01AE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F3207A-CCB5-E14B-BE08-61F3E8AA9353}" type="datetimeFigureOut">
              <a:rPr lang="fr-FR" smtClean="0"/>
              <a:t>12/07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99A9663-CDA6-1D44-8555-D7E3E3ABF4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83CCE13-14D3-2544-8342-CEA046064F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B5339B-EA7F-714A-B7DE-92AD8174262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6918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AAB06F-D80E-9B46-B2F9-5D98234AC0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565772"/>
            <a:ext cx="9144000" cy="1064246"/>
          </a:xfrm>
        </p:spPr>
        <p:txBody>
          <a:bodyPr>
            <a:noAutofit/>
          </a:bodyPr>
          <a:lstStyle/>
          <a:p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–B</a:t>
            </a:r>
            <a:br>
              <a:rPr lang="fr-FR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fr-FR" sz="2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438A2C6-B073-964C-9323-5C66E6BBFD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99240" y="2345635"/>
            <a:ext cx="10786359" cy="2912165"/>
          </a:xfrm>
        </p:spPr>
        <p:txBody>
          <a:bodyPr>
            <a:normAutofit/>
          </a:bodyPr>
          <a:lstStyle/>
          <a:p>
            <a:pPr algn="just">
              <a:lnSpc>
                <a:spcPct val="150000"/>
              </a:lnSpc>
            </a:pP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s 1-5.  The preference questionnaire filled out by the participants prior to the ECOCAPTURE scenario.</a:t>
            </a:r>
          </a:p>
          <a:p>
            <a:pPr algn="just">
              <a:lnSpc>
                <a:spcPct val="150000"/>
              </a:lnSpc>
            </a:pP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. 	The preference questionnaire guidelines.</a:t>
            </a:r>
          </a:p>
          <a:p>
            <a:pPr algn="just">
              <a:lnSpc>
                <a:spcPct val="150000"/>
              </a:lnSpc>
            </a:pP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.  How we customized the waiting room according to the preference questionnaire answers.</a:t>
            </a:r>
            <a:r>
              <a:rPr lang="fr-F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010325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11">
            <a:extLst>
              <a:ext uri="{FF2B5EF4-FFF2-40B4-BE49-F238E27FC236}">
                <a16:creationId xmlns:a16="http://schemas.microsoft.com/office/drawing/2014/main" id="{DA787963-048A-004B-A96A-9EF7C4699E9D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6532" y="798897"/>
            <a:ext cx="4177364" cy="5818472"/>
          </a:xfrm>
          <a:prstGeom prst="rect">
            <a:avLst/>
          </a:prstGeom>
          <a:ln w="19050">
            <a:solidFill>
              <a:schemeClr val="accent1"/>
            </a:solidFill>
          </a:ln>
        </p:spPr>
      </p:pic>
      <p:pic>
        <p:nvPicPr>
          <p:cNvPr id="8" name="Picture 10">
            <a:extLst>
              <a:ext uri="{FF2B5EF4-FFF2-40B4-BE49-F238E27FC236}">
                <a16:creationId xmlns:a16="http://schemas.microsoft.com/office/drawing/2014/main" id="{ACB04BAC-2352-2D4A-AE77-C5A490D4F5A9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2417" y="798897"/>
            <a:ext cx="4389121" cy="5818472"/>
          </a:xfrm>
          <a:prstGeom prst="rect">
            <a:avLst/>
          </a:prstGeom>
          <a:ln w="19050">
            <a:solidFill>
              <a:schemeClr val="accent1"/>
            </a:solidFill>
          </a:ln>
        </p:spPr>
      </p:pic>
      <p:sp>
        <p:nvSpPr>
          <p:cNvPr id="11" name="Titre 1">
            <a:extLst>
              <a:ext uri="{FF2B5EF4-FFF2-40B4-BE49-F238E27FC236}">
                <a16:creationId xmlns:a16="http://schemas.microsoft.com/office/drawing/2014/main" id="{D977A1ED-7201-5947-A736-236AA39893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44617" y="153369"/>
            <a:ext cx="10515600" cy="385646"/>
          </a:xfrm>
        </p:spPr>
        <p:txBody>
          <a:bodyPr>
            <a:noAutofit/>
          </a:bodyPr>
          <a:lstStyle/>
          <a:p>
            <a:pPr algn="ctr"/>
            <a:b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-2. The preference questionnaire page #1-2.     </a:t>
            </a:r>
            <a:br>
              <a:rPr lang="fr-F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fr-FR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93848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re 1">
            <a:extLst>
              <a:ext uri="{FF2B5EF4-FFF2-40B4-BE49-F238E27FC236}">
                <a16:creationId xmlns:a16="http://schemas.microsoft.com/office/drawing/2014/main" id="{616CB69F-605C-504C-8409-DB9ACCADE5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44617" y="153369"/>
            <a:ext cx="10515600" cy="385646"/>
          </a:xfrm>
        </p:spPr>
        <p:txBody>
          <a:bodyPr>
            <a:noAutofit/>
          </a:bodyPr>
          <a:lstStyle/>
          <a:p>
            <a:pPr algn="ctr"/>
            <a:b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-4. The preference questionnaire page #3-4. </a:t>
            </a:r>
            <a:br>
              <a:rPr lang="fr-F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fr-FR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8">
            <a:extLst>
              <a:ext uri="{FF2B5EF4-FFF2-40B4-BE49-F238E27FC236}">
                <a16:creationId xmlns:a16="http://schemas.microsoft.com/office/drawing/2014/main" id="{1557CE4E-65C0-F943-97CA-9DFDB18109AA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19"/>
          <a:stretch/>
        </p:blipFill>
        <p:spPr bwMode="auto">
          <a:xfrm>
            <a:off x="718100" y="760396"/>
            <a:ext cx="4864552" cy="5694513"/>
          </a:xfrm>
          <a:prstGeom prst="rect">
            <a:avLst/>
          </a:prstGeom>
          <a:ln w="19050">
            <a:solidFill>
              <a:schemeClr val="accent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" name="Picture 3">
            <a:extLst>
              <a:ext uri="{FF2B5EF4-FFF2-40B4-BE49-F238E27FC236}">
                <a16:creationId xmlns:a16="http://schemas.microsoft.com/office/drawing/2014/main" id="{AAB669C2-D46C-F743-A0C4-707AA083B9D7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0683" y="760396"/>
            <a:ext cx="4268319" cy="5694513"/>
          </a:xfrm>
          <a:prstGeom prst="rect">
            <a:avLst/>
          </a:prstGeom>
          <a:ln w="19050"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14062335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re 1">
            <a:extLst>
              <a:ext uri="{FF2B5EF4-FFF2-40B4-BE49-F238E27FC236}">
                <a16:creationId xmlns:a16="http://schemas.microsoft.com/office/drawing/2014/main" id="{E056A31A-981E-034E-A2A1-1EFD5E1FD7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44617" y="153369"/>
            <a:ext cx="10515600" cy="385646"/>
          </a:xfrm>
        </p:spPr>
        <p:txBody>
          <a:bodyPr>
            <a:noAutofit/>
          </a:bodyPr>
          <a:lstStyle/>
          <a:p>
            <a:pPr algn="ctr"/>
            <a:br>
              <a:rPr lang="en-US" sz="1600" dirty="0"/>
            </a:b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. The preference questionnaire page #5.</a:t>
            </a:r>
            <a:r>
              <a:rPr lang="en-US" sz="1600" dirty="0"/>
              <a:t> </a:t>
            </a:r>
            <a:br>
              <a:rPr lang="fr-FR" sz="1600" dirty="0"/>
            </a:br>
            <a:endParaRPr lang="fr-FR" sz="1600" dirty="0"/>
          </a:p>
        </p:txBody>
      </p:sp>
      <p:pic>
        <p:nvPicPr>
          <p:cNvPr id="6" name="Picture 2">
            <a:extLst>
              <a:ext uri="{FF2B5EF4-FFF2-40B4-BE49-F238E27FC236}">
                <a16:creationId xmlns:a16="http://schemas.microsoft.com/office/drawing/2014/main" id="{9A912635-B945-144A-B405-D9E30322C6DF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9011" y="818148"/>
            <a:ext cx="4506812" cy="5753534"/>
          </a:xfrm>
          <a:prstGeom prst="rect">
            <a:avLst/>
          </a:prstGeom>
          <a:ln w="19050"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20197034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Espace réservé du contenu 9">
            <a:extLst>
              <a:ext uri="{FF2B5EF4-FFF2-40B4-BE49-F238E27FC236}">
                <a16:creationId xmlns:a16="http://schemas.microsoft.com/office/drawing/2014/main" id="{37DA0550-D0F6-F94F-BB14-2BC23704A4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726577" y="962527"/>
            <a:ext cx="6299457" cy="5582652"/>
          </a:xfrm>
        </p:spPr>
      </p:pic>
      <p:sp>
        <p:nvSpPr>
          <p:cNvPr id="11" name="Titre 1">
            <a:extLst>
              <a:ext uri="{FF2B5EF4-FFF2-40B4-BE49-F238E27FC236}">
                <a16:creationId xmlns:a16="http://schemas.microsoft.com/office/drawing/2014/main" id="{35651728-422E-0B49-B83B-38747F1CEA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44617" y="153369"/>
            <a:ext cx="10515600" cy="385646"/>
          </a:xfrm>
        </p:spPr>
        <p:txBody>
          <a:bodyPr>
            <a:noAutofit/>
          </a:bodyPr>
          <a:lstStyle/>
          <a:p>
            <a:pPr algn="ctr"/>
            <a:b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. The preference questionnaire guidelines     </a:t>
            </a:r>
            <a:br>
              <a:rPr lang="fr-F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fr-FR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30085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re 1">
            <a:extLst>
              <a:ext uri="{FF2B5EF4-FFF2-40B4-BE49-F238E27FC236}">
                <a16:creationId xmlns:a16="http://schemas.microsoft.com/office/drawing/2014/main" id="{14815E3F-57BB-0047-88E6-6CFBD2F759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3255" y="153369"/>
            <a:ext cx="11723884" cy="433040"/>
          </a:xfrm>
        </p:spPr>
        <p:txBody>
          <a:bodyPr>
            <a:noAutofit/>
          </a:bodyPr>
          <a:lstStyle/>
          <a:p>
            <a:pPr algn="ctr"/>
            <a:b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. How we customized the waiting room according to the preference questionnaire answers.      </a:t>
            </a:r>
            <a:br>
              <a:rPr lang="fr-F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fr-FR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3074BAC3-BFA1-DF4B-95FD-1251F1CCF0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08294" y="1405287"/>
            <a:ext cx="5788459" cy="2913245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25529573-248A-0C40-AB47-5E67195161A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3255" y="1405287"/>
            <a:ext cx="5791249" cy="42880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407867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24</Words>
  <Application>Microsoft Macintosh PowerPoint</Application>
  <PresentationFormat>Grand écran</PresentationFormat>
  <Paragraphs>9</Paragraphs>
  <Slides>6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Thème Office</vt:lpstr>
      <vt:lpstr>Supplementary material–B </vt:lpstr>
      <vt:lpstr> Figure 1-2. The preference questionnaire page #1-2.      </vt:lpstr>
      <vt:lpstr> Figure 3-4. The preference questionnaire page #3-4.  </vt:lpstr>
      <vt:lpstr> Figure 5. The preference questionnaire page #5.  </vt:lpstr>
      <vt:lpstr> Figure 6. The preference questionnaire guidelines      </vt:lpstr>
      <vt:lpstr> Figure 7. How we customized the waiting room according to the preference questionnaire answers.       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batrancourt@gmail.com</dc:creator>
  <cp:lastModifiedBy>bbatrancourt@gmail.com</cp:lastModifiedBy>
  <cp:revision>10</cp:revision>
  <dcterms:created xsi:type="dcterms:W3CDTF">2019-05-24T21:13:18Z</dcterms:created>
  <dcterms:modified xsi:type="dcterms:W3CDTF">2019-07-12T15:50:48Z</dcterms:modified>
</cp:coreProperties>
</file>